
<file path=[Content_Types].xml><?xml version="1.0" encoding="utf-8"?>
<Types xmlns="http://schemas.openxmlformats.org/package/2006/content-types">
  <Default Extension="bin" ContentType="application/vnd.openxmlformats-officedocument.oleObject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wmf" ContentType="image/x-wmf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Default Extension="vml" ContentType="application/vnd.openxmlformats-officedocument.vmlDrawing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10" d="100"/>
          <a:sy n="110" d="100"/>
        </p:scale>
        <p:origin x="-720" y="77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66731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8432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15068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46326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83120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458147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32121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276904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6822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9109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31095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87FDE6-4241-408B-992D-9EBF3DF94491}" type="datetimeFigureOut">
              <a:rPr lang="it-IT" smtClean="0"/>
              <a:t>11/03/201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4B7B08-3C86-441F-8806-F29404A3F7ED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41332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2844094" y="5898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6200000">
            <a:off x="2326548" y="1936595"/>
            <a:ext cx="13864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rface </a:t>
            </a:r>
            <a:r>
              <a:rPr lang="it-IT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a 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it-IT" sz="1200" dirty="0" smtClean="0">
                <a:latin typeface="Symbol" panose="05050102010706020507" pitchFamily="18" charset="2"/>
              </a:rPr>
              <a:t>m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r>
              <a:rPr lang="it-IT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3131840" y="620713"/>
            <a:ext cx="2449206" cy="2879725"/>
            <a:chOff x="3347864" y="620713"/>
            <a:chExt cx="2449206" cy="2879725"/>
          </a:xfrm>
        </p:grpSpPr>
        <p:graphicFrame>
          <p:nvGraphicFramePr>
            <p:cNvPr id="4" name="Object 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21185230"/>
                </p:ext>
              </p:extLst>
            </p:nvPr>
          </p:nvGraphicFramePr>
          <p:xfrm>
            <a:off x="3602038" y="620713"/>
            <a:ext cx="1935162" cy="28797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112" name="Graph" r:id="rId3" imgW="2151360" imgH="2819520" progId="Origin50.Graph">
                    <p:embed/>
                  </p:oleObj>
                </mc:Choice>
                <mc:Fallback>
                  <p:oleObj name="Graph" r:id="rId3" imgW="2151360" imgH="2819520" progId="Origin50.Graph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3602038" y="620713"/>
                          <a:ext cx="1935162" cy="28797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21" name="Group 20"/>
            <p:cNvGrpSpPr/>
            <p:nvPr/>
          </p:nvGrpSpPr>
          <p:grpSpPr>
            <a:xfrm>
              <a:off x="3347864" y="942236"/>
              <a:ext cx="498855" cy="2265716"/>
              <a:chOff x="3347864" y="942236"/>
              <a:chExt cx="498855" cy="2265716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3347864" y="942236"/>
                <a:ext cx="49885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0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3354276" y="1336729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0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3354276" y="1736961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0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3354276" y="2137387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0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3354276" y="2538112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0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3585109" y="2930953"/>
                <a:ext cx="2616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>
              <a:off x="4794873" y="799029"/>
              <a:ext cx="89159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3CR1</a:t>
              </a:r>
              <a:r>
                <a:rPr lang="it-IT" sz="10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/GFP</a:t>
              </a:r>
              <a:endParaRPr lang="it-IT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794873" y="951429"/>
              <a:ext cx="10021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X3CR1</a:t>
              </a:r>
              <a:r>
                <a:rPr lang="it-IT" sz="10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FP/GFP</a:t>
              </a:r>
              <a:endParaRPr lang="it-IT" sz="10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2844094" y="3429000"/>
            <a:ext cx="2889995" cy="3028104"/>
            <a:chOff x="2844094" y="3429000"/>
            <a:chExt cx="2889995" cy="3028104"/>
          </a:xfrm>
        </p:grpSpPr>
        <p:grpSp>
          <p:nvGrpSpPr>
            <p:cNvPr id="36" name="Group 35"/>
            <p:cNvGrpSpPr/>
            <p:nvPr/>
          </p:nvGrpSpPr>
          <p:grpSpPr>
            <a:xfrm>
              <a:off x="2844094" y="3429000"/>
              <a:ext cx="2889995" cy="2929468"/>
              <a:chOff x="2844094" y="3811900"/>
              <a:chExt cx="2889995" cy="2929468"/>
            </a:xfrm>
          </p:grpSpPr>
          <p:sp>
            <p:nvSpPr>
              <p:cNvPr id="7" name="TextBox 6"/>
              <p:cNvSpPr txBox="1"/>
              <p:nvPr/>
            </p:nvSpPr>
            <p:spPr>
              <a:xfrm>
                <a:off x="2844094" y="3811900"/>
                <a:ext cx="35137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it-IT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2" name="Object 1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609399690"/>
                  </p:ext>
                </p:extLst>
              </p:nvPr>
            </p:nvGraphicFramePr>
            <p:xfrm>
              <a:off x="3357602" y="3996580"/>
              <a:ext cx="2376487" cy="27447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113" name="Graph" r:id="rId5" imgW="2151360" imgH="2710080" progId="Origin50.Graph">
                      <p:embed/>
                    </p:oleObj>
                  </mc:Choice>
                  <mc:Fallback>
                    <p:oleObj name="Graph" r:id="rId5" imgW="2151360" imgH="2710080" progId="Origin50.Graph">
                      <p:embed/>
                      <p:pic>
                        <p:nvPicPr>
                          <p:cNvPr id="0" name=""/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3357602" y="3996580"/>
                            <a:ext cx="2376487" cy="2744788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cxnSp>
            <p:nvCxnSpPr>
              <p:cNvPr id="8" name="Straight Connector 7"/>
              <p:cNvCxnSpPr/>
              <p:nvPr/>
            </p:nvCxnSpPr>
            <p:spPr>
              <a:xfrm>
                <a:off x="4433822" y="4688112"/>
                <a:ext cx="28803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4426186" y="4497838"/>
                <a:ext cx="27443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*</a:t>
                </a:r>
                <a:endParaRPr lang="it-IT" sz="1400" dirty="0"/>
              </a:p>
            </p:txBody>
          </p:sp>
          <p:cxnSp>
            <p:nvCxnSpPr>
              <p:cNvPr id="10" name="Straight Connector 9"/>
              <p:cNvCxnSpPr/>
              <p:nvPr/>
            </p:nvCxnSpPr>
            <p:spPr>
              <a:xfrm>
                <a:off x="5098916" y="4209848"/>
                <a:ext cx="28803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TextBox 10"/>
              <p:cNvSpPr txBox="1"/>
              <p:nvPr/>
            </p:nvSpPr>
            <p:spPr>
              <a:xfrm>
                <a:off x="5053410" y="4019574"/>
                <a:ext cx="36420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400" dirty="0" smtClean="0"/>
                  <a:t>**</a:t>
                </a:r>
                <a:endParaRPr lang="it-IT" sz="1400" dirty="0"/>
              </a:p>
            </p:txBody>
          </p:sp>
          <p:grpSp>
            <p:nvGrpSpPr>
              <p:cNvPr id="35" name="Group 34"/>
              <p:cNvGrpSpPr/>
              <p:nvPr/>
            </p:nvGrpSpPr>
            <p:grpSpPr>
              <a:xfrm>
                <a:off x="3286581" y="4136452"/>
                <a:ext cx="339790" cy="2316884"/>
                <a:chOff x="3286581" y="4136452"/>
                <a:chExt cx="339790" cy="2316884"/>
              </a:xfrm>
            </p:grpSpPr>
            <p:sp>
              <p:nvSpPr>
                <p:cNvPr id="25" name="TextBox 24"/>
                <p:cNvSpPr txBox="1"/>
                <p:nvPr/>
              </p:nvSpPr>
              <p:spPr>
                <a:xfrm>
                  <a:off x="3286581" y="4136452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3286581" y="4481167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3286581" y="4820904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0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" name="TextBox 27"/>
                <p:cNvSpPr txBox="1"/>
                <p:nvPr/>
              </p:nvSpPr>
              <p:spPr>
                <a:xfrm>
                  <a:off x="3286581" y="5163130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3286581" y="5492728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3364761" y="6176337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0</a:t>
                  </a:r>
                  <a:endPara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364761" y="5840888"/>
                  <a:ext cx="2616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it-IT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</p:grpSp>
          <p:sp>
            <p:nvSpPr>
              <p:cNvPr id="32" name="TextBox 31"/>
              <p:cNvSpPr txBox="1"/>
              <p:nvPr/>
            </p:nvSpPr>
            <p:spPr>
              <a:xfrm>
                <a:off x="3972894" y="4176040"/>
                <a:ext cx="89159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3CR1</a:t>
                </a:r>
                <a:r>
                  <a:rPr lang="it-IT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/GFP</a:t>
                </a:r>
                <a:endParaRPr lang="it-IT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3972894" y="4328440"/>
                <a:ext cx="100219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X3CR1</a:t>
                </a:r>
                <a:r>
                  <a:rPr lang="it-IT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FP/GFP</a:t>
                </a:r>
                <a:endParaRPr lang="it-IT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 rot="16200000">
                <a:off x="2249380" y="5156395"/>
                <a:ext cx="154080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ell </a:t>
                </a:r>
                <a:r>
                  <a:rPr lang="it-IT" sz="12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pacitance </a:t>
                </a:r>
                <a:r>
                  <a:rPr lang="it-IT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(pF)</a:t>
                </a:r>
                <a:endParaRPr lang="it-IT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8" name="TextBox 37"/>
            <p:cNvSpPr txBox="1"/>
            <p:nvPr/>
          </p:nvSpPr>
          <p:spPr>
            <a:xfrm>
              <a:off x="4285129" y="6180105"/>
              <a:ext cx="5854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NWs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3709652" y="591821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2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365140" y="591821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-4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5020262" y="5918216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-6</a:t>
              </a:r>
              <a:endParaRPr lang="it-IT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TextBox 42"/>
          <p:cNvSpPr txBox="1"/>
          <p:nvPr/>
        </p:nvSpPr>
        <p:spPr>
          <a:xfrm>
            <a:off x="4591509" y="198490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400" dirty="0" smtClean="0"/>
              <a:t>**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566730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1305341"/>
            <a:ext cx="7848872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Quantitative morphometric analysis of microglial cells 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ppocampal slices 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NW 6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 chart displaying the surface area of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cyt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loaded microglia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purple bar) an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orange bar) slices. Note tha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pla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duce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rface area respect t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/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4662 ± 404 m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 = 15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1816 ± 286 mm</a:t>
            </a:r>
            <a:r>
              <a:rPr lang="en-US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n = 16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, p &lt; 0.001, unpaired t-tes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 capacitance of CX3CR1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</a:t>
            </a:r>
            <a:r>
              <a:rPr lang="en-US" sz="12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croglia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during postnatal hippocampal development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r chart showing microglial cell capacitance in PNWs from 1 to 6 in 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urple bars) and 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orange bars) slices. Note that the in both genotypes cell capacitance increase during PNWs 1-6; 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ells display lower capacitance respect to CX3CR1</a:t>
            </a:r>
            <a:r>
              <a:rPr lang="en-US" sz="12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+/GFP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from PNWs 3-4 (PNWs 3-4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GFP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1.7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7.9 pF, n = 101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19.5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6.0 pF, n = 81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, p &lt; 0.05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 PNWs 5-6: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/GFP 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8.3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0.7 pF, n = 63;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X3CR1</a:t>
            </a:r>
            <a:r>
              <a:rPr lang="en-US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/GFP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23.7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±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0.7 pF, n = 63,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, p&lt;0.001, t test)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331738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01DA381CDEBC44A43FD1EA39CD529A" ma:contentTypeVersion="7" ma:contentTypeDescription="Create a new document." ma:contentTypeScope="" ma:versionID="810b3f26048e4a87389945157ea0e72d">
  <xsd:schema xmlns:xsd="http://www.w3.org/2001/XMLSchema" xmlns:p="http://schemas.microsoft.com/office/2006/metadata/properties" xmlns:ns2="3998502f-f40c-4b7f-935a-9b232a321072" targetNamespace="http://schemas.microsoft.com/office/2006/metadata/properties" ma:root="true" ma:fieldsID="d2da522b91789f75ab4807fdb0d46912" ns2:_="">
    <xsd:import namespace="3998502f-f40c-4b7f-935a-9b232a32107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98502f-f40c-4b7f-935a-9b232a32107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98502f-f40c-4b7f-935a-9b232a321072">Presentation</DocumentType>
    <TitleName xmlns="3998502f-f40c-4b7f-935a-9b232a321072">Presentation 2.PPTX</TitleName>
    <Checked_x0020_Out_x0020_To xmlns="3998502f-f40c-4b7f-935a-9b232a321072">
      <UserInfo>
        <DisplayName/>
        <AccountId xsi:nil="true"/>
        <AccountType/>
      </UserInfo>
    </Checked_x0020_Out_x0020_To>
    <IsDeleted xmlns="3998502f-f40c-4b7f-935a-9b232a321072">false</IsDeleted>
    <DocumentId xmlns="3998502f-f40c-4b7f-935a-9b232a321072">Presentation 2.PPTX</DocumentId>
    <FileFormat xmlns="3998502f-f40c-4b7f-935a-9b232a321072">PPTX</FileFormat>
    <StageName xmlns="3998502f-f40c-4b7f-935a-9b232a321072" xsi:nil="true"/>
  </documentManagement>
</p:properties>
</file>

<file path=customXml/itemProps1.xml><?xml version="1.0" encoding="utf-8"?>
<ds:datastoreItem xmlns:ds="http://schemas.openxmlformats.org/officeDocument/2006/customXml" ds:itemID="{897EB283-EB65-40AD-B77C-2CF65F382A01}"/>
</file>

<file path=customXml/itemProps2.xml><?xml version="1.0" encoding="utf-8"?>
<ds:datastoreItem xmlns:ds="http://schemas.openxmlformats.org/officeDocument/2006/customXml" ds:itemID="{69E0771D-9C58-425D-8535-05DD18DFDD36}"/>
</file>

<file path=customXml/itemProps3.xml><?xml version="1.0" encoding="utf-8"?>
<ds:datastoreItem xmlns:ds="http://schemas.openxmlformats.org/officeDocument/2006/customXml" ds:itemID="{68F4BD0F-65C7-4A3F-8B85-1C664CD70BF5}"/>
</file>

<file path=docProps/app.xml><?xml version="1.0" encoding="utf-8"?>
<Properties xmlns="http://schemas.openxmlformats.org/officeDocument/2006/extended-properties" xmlns:vt="http://schemas.openxmlformats.org/officeDocument/2006/docPropsVTypes">
  <TotalTime>532</TotalTime>
  <Words>271</Words>
  <Application>Microsoft Office PowerPoint</Application>
  <PresentationFormat>On-screen Show (4:3)</PresentationFormat>
  <Paragraphs>29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Office Theme</vt:lpstr>
      <vt:lpstr>Graph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Pagani</dc:creator>
  <cp:lastModifiedBy>Francesca Pagani</cp:lastModifiedBy>
  <cp:revision>37</cp:revision>
  <dcterms:created xsi:type="dcterms:W3CDTF">2014-09-23T20:06:38Z</dcterms:created>
  <dcterms:modified xsi:type="dcterms:W3CDTF">2015-03-11T14:01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01DA381CDEBC44A43FD1EA39CD529A</vt:lpwstr>
  </property>
</Properties>
</file>